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53" d="100"/>
          <a:sy n="53" d="100"/>
        </p:scale>
        <p:origin x="276" y="4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19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dirty="0"/>
              <a:t>Diagnostic accuracy of dynamic CZT-SPECT in coronary artery </a:t>
            </a:r>
            <a:r>
              <a:rPr lang="en-US" altLang="en-US" sz="2000" dirty="0" err="1"/>
              <a:t>disease.A</a:t>
            </a:r>
            <a:r>
              <a:rPr lang="en-US" altLang="en-US" sz="2000" dirty="0"/>
              <a:t> systematic review and meta-analysis.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200" dirty="0"/>
              <a:t>Mariska Panjer1, Magdalena Dobrolinska1,2, Nils R.L Wagenaar3,4, Riemer H.J.A Slart1,3</a:t>
            </a:r>
          </a:p>
          <a:p>
            <a:pPr marL="0" lvl="1"/>
            <a:r>
              <a:rPr lang="en-US" altLang="en-US" sz="1200" dirty="0"/>
              <a:t>Affiliations:</a:t>
            </a:r>
          </a:p>
          <a:p>
            <a:pPr marL="0" lvl="1"/>
            <a:r>
              <a:rPr lang="en-US" altLang="en-US" sz="1200" dirty="0"/>
              <a:t>1University Medical Center Groningen, 2Medical University of Silesia, 3University of Twente, 4Ziekenhuis </a:t>
            </a:r>
            <a:r>
              <a:rPr lang="en-US" altLang="en-US" sz="1200" dirty="0" err="1"/>
              <a:t>Groep</a:t>
            </a:r>
            <a:r>
              <a:rPr lang="en-US" altLang="en-US" sz="1200" dirty="0"/>
              <a:t> Twente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A1B6FF1-63DF-44B1-A69A-EC5148A1C6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43600" y="4298806"/>
            <a:ext cx="1162050" cy="685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1B7E278-DDAD-428A-BBBF-E9445F8CB3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87795" y="4210050"/>
            <a:ext cx="876300" cy="81915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>
                <a:solidFill>
                  <a:srgbClr val="000000"/>
                </a:solidFill>
              </a:rPr>
              <a:t>1-PET is the non invasive gold standard in the CAD diagnosis</a:t>
            </a:r>
          </a:p>
          <a:p>
            <a:pPr marL="0" indent="0">
              <a:buNone/>
            </a:pPr>
            <a:r>
              <a:rPr lang="en-US" altLang="en-US" sz="2400" dirty="0">
                <a:solidFill>
                  <a:srgbClr val="000000"/>
                </a:solidFill>
              </a:rPr>
              <a:t>2-In contrast to PET, SPECT is less expensive, wider, and more easily available.</a:t>
            </a:r>
          </a:p>
          <a:p>
            <a:pPr marL="0" indent="0">
              <a:buNone/>
            </a:pPr>
            <a:r>
              <a:rPr lang="en-US" altLang="en-US" sz="2400" dirty="0">
                <a:solidFill>
                  <a:srgbClr val="000000"/>
                </a:solidFill>
              </a:rPr>
              <a:t>3-The recently introduced CZT camera have a higher resolution and shorter acquisition time, this not only improves the overall SPECT performance, but also decreases radiation dose.</a:t>
            </a:r>
          </a:p>
          <a:p>
            <a:pPr marL="0" indent="0">
              <a:buNone/>
            </a:pPr>
            <a:r>
              <a:rPr lang="en-US" altLang="en-US" sz="2400" dirty="0">
                <a:solidFill>
                  <a:srgbClr val="000000"/>
                </a:solidFill>
              </a:rPr>
              <a:t>4-The comparison between dynamic CZT SPECT and clinical standards used in CAD diagnosis has not been available ye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A.	Study type:</a:t>
            </a:r>
          </a:p>
          <a:p>
            <a:pPr marL="857250" lvl="1" indent="-457200">
              <a:buAutoNum type="alphaUcPeriod"/>
            </a:pPr>
            <a:r>
              <a:rPr lang="en-US" altLang="en-US" sz="2000" dirty="0"/>
              <a:t>A systematic review and meta-analysis.</a:t>
            </a:r>
          </a:p>
          <a:p>
            <a:pPr marL="0" indent="0">
              <a:buNone/>
            </a:pPr>
            <a:r>
              <a:rPr lang="en-US" altLang="en-US" sz="2000" dirty="0"/>
              <a:t> </a:t>
            </a:r>
          </a:p>
          <a:p>
            <a:pPr marL="0" indent="0">
              <a:buNone/>
            </a:pPr>
            <a:r>
              <a:rPr lang="en-US" altLang="en-US" sz="2000" dirty="0"/>
              <a:t>B.	Study subjects: studies which reported to perform dynamic CZT-SPECT and within half a year the methodological references coronary angiography with FFR and positron emission tomography</a:t>
            </a:r>
          </a:p>
          <a:p>
            <a:pPr marL="0" indent="0">
              <a:buNone/>
            </a:pPr>
            <a:r>
              <a:rPr lang="en-US" altLang="en-US" sz="2000" dirty="0"/>
              <a:t>C.	Study endpoints:</a:t>
            </a:r>
          </a:p>
          <a:p>
            <a:pPr marL="0" indent="0">
              <a:buNone/>
            </a:pPr>
            <a:r>
              <a:rPr lang="en-US" altLang="en-US" sz="2000" dirty="0"/>
              <a:t>	A.	Primary end point(s): sensitivity and specificity</a:t>
            </a:r>
          </a:p>
          <a:p>
            <a:pPr marL="0" indent="0">
              <a:buNone/>
            </a:pPr>
            <a:r>
              <a:rPr lang="en-US" altLang="en-US" sz="2000" dirty="0"/>
              <a:t>	B.	Secondary end point(s): negative likelihood ratio, positive likelihood ratio, diagnostic odds ratio and heterogeneity</a:t>
            </a:r>
          </a:p>
          <a:p>
            <a:pPr marL="0" indent="0">
              <a:buNone/>
            </a:pPr>
            <a:r>
              <a:rPr lang="en-US" altLang="en-US" sz="2000" dirty="0"/>
              <a:t>D.	Study variables: true positive, true negative, false positive, false negative                        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EB9B8A9D-258C-4D83-8CBE-76024306CD7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14085" y="1677845"/>
            <a:ext cx="7163429" cy="3185319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29707A39-777B-4EB0-949C-180D20CE6C4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68486" y="1662681"/>
            <a:ext cx="7425546" cy="3986194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	Overall, dynamic CZT-SPECT MPI has a good diagnostic sensitivity and specificity for CAD diagnosis as compared to gold standards used in clinical practice.</a:t>
            </a:r>
          </a:p>
          <a:p>
            <a:pPr marL="0" indent="0">
              <a:buNone/>
            </a:pPr>
            <a:r>
              <a:rPr lang="en-US" altLang="en-US" sz="2400" dirty="0"/>
              <a:t>2-	However, due to the heterogeneity of the methodologies between the CZT-SPECT MPI studies and the gold standards, and the relatively small number of included studies, it warrants further well-defined research protocol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Words>420</Words>
  <Application>Microsoft Office PowerPoint</Application>
  <PresentationFormat>On-screen Show (4:3)</PresentationFormat>
  <Paragraphs>3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iagnostic accuracy of dynamic CZT-SPECT in coronary artery disease.A systematic review and meta-analysis.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ara Dailey</cp:lastModifiedBy>
  <cp:revision>101</cp:revision>
  <dcterms:created xsi:type="dcterms:W3CDTF">2011-04-18T21:44:13Z</dcterms:created>
  <dcterms:modified xsi:type="dcterms:W3CDTF">2021-07-19T19:45:09Z</dcterms:modified>
</cp:coreProperties>
</file>